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640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409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055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569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6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104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25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2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677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757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64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153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6EB4B-12DF-4C8E-9497-8CB3B6C47D5C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9A254-F062-4477-BE63-B4FAED94144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736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221974" y="34114"/>
            <a:ext cx="11748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: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phylum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generated in R (version 4.2.1) (https://www.r-project.org/) using package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atmap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1.0.12)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203" y="622666"/>
            <a:ext cx="11409593" cy="6220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1712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Laconi Andrea</cp:lastModifiedBy>
  <cp:revision>5</cp:revision>
  <dcterms:created xsi:type="dcterms:W3CDTF">2022-03-07T16:09:37Z</dcterms:created>
  <dcterms:modified xsi:type="dcterms:W3CDTF">2022-11-14T14:18:09Z</dcterms:modified>
</cp:coreProperties>
</file>